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09"/>
  </p:normalViewPr>
  <p:slideViewPr>
    <p:cSldViewPr snapToGrid="0" snapToObjects="1">
      <p:cViewPr varScale="1">
        <p:scale>
          <a:sx n="59" d="100"/>
          <a:sy n="59" d="100"/>
        </p:scale>
        <p:origin x="9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7CE391-BAFB-9E45-AF58-9F376C74FB3E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9DE25-F9C1-1544-9DD0-B91840336C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255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87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999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074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7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788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561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046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2210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789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0155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442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9AA3F-2112-A249-BDC0-1C4520AE6B79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78662-0EA1-CE4C-A4A8-BEB98A1F56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BDD8B16-5B66-71B7-7337-899FB347F3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612" t="6223" r="35481" b="42065"/>
          <a:stretch/>
        </p:blipFill>
        <p:spPr>
          <a:xfrm>
            <a:off x="3808570" y="731520"/>
            <a:ext cx="5078071" cy="431153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D5403BC-055F-083B-BA33-13E1AF13DC97}"/>
              </a:ext>
            </a:extLst>
          </p:cNvPr>
          <p:cNvSpPr txBox="1"/>
          <p:nvPr/>
        </p:nvSpPr>
        <p:spPr>
          <a:xfrm>
            <a:off x="228060" y="48008"/>
            <a:ext cx="11913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6012872" y="5043055"/>
            <a:ext cx="116996" cy="2062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15F2D82-E221-0385-1AAB-0BFB6E80A33C}"/>
              </a:ext>
            </a:extLst>
          </p:cNvPr>
          <p:cNvSpPr txBox="1"/>
          <p:nvPr/>
        </p:nvSpPr>
        <p:spPr>
          <a:xfrm>
            <a:off x="8173082" y="4807640"/>
            <a:ext cx="94915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B468FB2-C121-C0F8-5D9D-0D61D94AC260}"/>
              </a:ext>
            </a:extLst>
          </p:cNvPr>
          <p:cNvSpPr txBox="1"/>
          <p:nvPr/>
        </p:nvSpPr>
        <p:spPr>
          <a:xfrm rot="16200000">
            <a:off x="2231698" y="2607928"/>
            <a:ext cx="268256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elapse-free survival rat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DA8282B-D3B2-7858-804D-1F0A7E83D4F9}"/>
              </a:ext>
            </a:extLst>
          </p:cNvPr>
          <p:cNvSpPr txBox="1"/>
          <p:nvPr/>
        </p:nvSpPr>
        <p:spPr>
          <a:xfrm>
            <a:off x="1687286" y="5559166"/>
            <a:ext cx="986245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6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plan-Meier curve</a:t>
            </a:r>
            <a:r>
              <a:rPr lang="en-US" altLang="ja-JP" sz="16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f the relapse-free survival rate for patients who achieved complete remission </a:t>
            </a:r>
          </a:p>
          <a:p>
            <a:pPr algn="just"/>
            <a:r>
              <a:rPr lang="en-US" altLang="ja-JP" sz="16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fter fertility-sparing therapies</a:t>
            </a:r>
            <a:endParaRPr lang="en-US" altLang="ja-JP" sz="1600" b="1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16075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0</TotalTime>
  <Words>23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Yu Gothic</vt:lpstr>
      <vt:lpstr>Yu Gothic Light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田口 歩</cp:lastModifiedBy>
  <cp:revision>39</cp:revision>
  <dcterms:created xsi:type="dcterms:W3CDTF">2022-12-12T03:44:47Z</dcterms:created>
  <dcterms:modified xsi:type="dcterms:W3CDTF">2023-01-13T08:24:10Z</dcterms:modified>
</cp:coreProperties>
</file>